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144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go Masaki" userId="e657396fbe83e9a5" providerId="LiveId" clId="{0E6B0EA3-0CC6-492D-883F-7266A2758769}"/>
    <pc:docChg chg="undo redo custSel modSld">
      <pc:chgData name="Tago Masaki" userId="e657396fbe83e9a5" providerId="LiveId" clId="{0E6B0EA3-0CC6-492D-883F-7266A2758769}" dt="2021-03-01T08:39:10.002" v="66" actId="1076"/>
      <pc:docMkLst>
        <pc:docMk/>
      </pc:docMkLst>
      <pc:sldChg chg="addSp delSp modSp mod">
        <pc:chgData name="Tago Masaki" userId="e657396fbe83e9a5" providerId="LiveId" clId="{0E6B0EA3-0CC6-492D-883F-7266A2758769}" dt="2021-03-01T08:36:00.778" v="63" actId="1076"/>
        <pc:sldMkLst>
          <pc:docMk/>
          <pc:sldMk cId="1840328938" sldId="256"/>
        </pc:sldMkLst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" creationId="{10ABC092-09F1-1F40-9A0D-91FDAA4CAF20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" creationId="{69873C2E-08D1-C842-BBFF-28D6F6CA94B4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4" creationId="{B5100356-97F8-9146-A0DB-8FAB8BC273D0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5" creationId="{5D82A814-52DD-FA4B-B0B6-D82B2618D4E2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9" creationId="{6E3DA42F-0EE7-F746-83E2-0D6287165CCE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11" creationId="{54CBB1EF-F005-0C47-AEED-6353F23865F8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12" creationId="{871ADB44-DCA3-AC47-ABB2-82EAF5633910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13" creationId="{A0A1AC26-6FBF-8B47-8B57-34E9524CD867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16" creationId="{E26FB539-BC1D-5D45-81E1-5AEAEF620037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17" creationId="{A56EA984-2051-EA4F-B386-36EC4E49EFAE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0" creationId="{655123A7-91D2-6D4B-A856-66592CBE931C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2" creationId="{A8A6E456-944E-0843-B09E-500F9875D15D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4" creationId="{5900DEB3-9986-B546-BCBC-18213D50EC3E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6" creationId="{9D7979A3-BB74-DF49-B0F8-75816FAF52F3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7" creationId="{00000000-0000-0000-0000-000000000000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28" creationId="{385249E6-1CB3-C447-B7C9-FE4ADB055383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0" creationId="{DC595FD1-2105-3E4D-88B6-3E8CF2B7941C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2" creationId="{C2EF0F19-B65D-0A4A-8CD6-B3C899082C43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3" creationId="{6D00FF1E-3502-2F45-A70C-1EF552092507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4" creationId="{1A0364C2-5E42-594E-8796-2B869401FED1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7" creationId="{45FC4413-1013-9D4E-9A38-62BE0F8F46CE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38" creationId="{C2C60E49-1252-E945-9E20-DDA117FDA1E3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42" creationId="{60E95549-2D1E-B040-893B-2C84A8D499E1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44" creationId="{C914C37A-8E70-E24F-B2C0-A74D9BD59B87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47" creationId="{4316E617-51CB-2545-993D-E87BD0D81A0D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49" creationId="{41FF6500-BF8D-174E-929E-5847DCB65016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55" creationId="{C5B8BC03-80A6-9749-BE5F-9631DA2FC9EE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57" creationId="{29A9552C-B393-C847-9540-29FFABF88F0B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59" creationId="{DC23E7A5-62A5-F840-9693-8F0615E83ED4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63" creationId="{E13BDD7D-23A5-B743-973B-93279F2B16A5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71" creationId="{00000000-0000-0000-0000-000000000000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73" creationId="{A96284BE-8E35-D74A-B20F-ED007620647E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74" creationId="{A1860C8A-4ADC-E145-AF41-DBB30A94A1EC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75" creationId="{DF3A0620-5D9D-EF47-9AFD-E2C986CCE7B7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76" creationId="{A4A628D2-8993-DE4B-BB26-81668664C50A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77" creationId="{35ECDFF2-3ED3-6544-BF62-5AFD12DC8F4E}"/>
          </ac:spMkLst>
        </pc:spChg>
        <pc:spChg chg="mod">
          <ac:chgData name="Tago Masaki" userId="e657396fbe83e9a5" providerId="LiveId" clId="{0E6B0EA3-0CC6-492D-883F-7266A2758769}" dt="2021-03-01T08:34:23.678" v="51" actId="1036"/>
          <ac:spMkLst>
            <pc:docMk/>
            <pc:sldMk cId="1840328938" sldId="256"/>
            <ac:spMk id="78" creationId="{D1984872-FF01-4B48-AB22-6C14494317EA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79" creationId="{FC5363C3-9801-0C4D-8517-EB14D8F6BF04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0" creationId="{C4D573E1-5A25-2F42-8E3B-21C2D5566759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1" creationId="{89B78755-6CFA-904A-B5B4-71F0D7B1E368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3" creationId="{E06997E3-F31B-D741-BB90-486974DD42F9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4" creationId="{5A33A3D1-800F-B44F-AE4A-6690DB50D647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5" creationId="{CED8A518-C47D-3C42-A612-F0D9BCC53012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6" creationId="{6E349939-B4CB-1C45-B9EE-77C54C425760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7" creationId="{1B720766-0609-5040-8E73-2D913A4E86EE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8" creationId="{61231EB2-A82C-214F-B6D9-5C1BFCEFAE6A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89" creationId="{5F949138-3D7F-477E-A27B-E12819C4B58B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90" creationId="{C5B8BC03-80A6-9749-BE5F-9631DA2FC9EE}"/>
          </ac:spMkLst>
        </pc:spChg>
        <pc:spChg chg="add del">
          <ac:chgData name="Tago Masaki" userId="e657396fbe83e9a5" providerId="LiveId" clId="{0E6B0EA3-0CC6-492D-883F-7266A2758769}" dt="2021-03-01T08:34:16.514" v="47" actId="22"/>
          <ac:spMkLst>
            <pc:docMk/>
            <pc:sldMk cId="1840328938" sldId="256"/>
            <ac:spMk id="91" creationId="{2EC93BDD-4B5F-466C-B01B-5848D048AC6D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92" creationId="{C5B8BC03-80A6-9749-BE5F-9631DA2FC9EE}"/>
          </ac:spMkLst>
        </pc:spChg>
        <pc:spChg chg="add del">
          <ac:chgData name="Tago Masaki" userId="e657396fbe83e9a5" providerId="LiveId" clId="{0E6B0EA3-0CC6-492D-883F-7266A2758769}" dt="2021-03-01T08:34:18.762" v="49" actId="22"/>
          <ac:spMkLst>
            <pc:docMk/>
            <pc:sldMk cId="1840328938" sldId="256"/>
            <ac:spMk id="93" creationId="{ABB2569D-86E8-4FC1-AE43-34722B11E4E1}"/>
          </ac:spMkLst>
        </pc:spChg>
        <pc:spChg chg="add mod">
          <ac:chgData name="Tago Masaki" userId="e657396fbe83e9a5" providerId="LiveId" clId="{0E6B0EA3-0CC6-492D-883F-7266A2758769}" dt="2021-03-01T08:36:00.778" v="63" actId="1076"/>
          <ac:spMkLst>
            <pc:docMk/>
            <pc:sldMk cId="1840328938" sldId="256"/>
            <ac:spMk id="94" creationId="{CC21B440-7E36-47B4-93E9-4A80B7A45FF1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12" creationId="{2FAEEAC3-81C5-4053-8518-8DDEAE1CA383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13" creationId="{FCBC03C5-0C22-46AA-8AC2-81007944D098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59" creationId="{00000000-0000-0000-0000-000000000000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73" creationId="{C5B8BC03-80A6-9749-BE5F-9631DA2FC9EE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79" creationId="{00000000-0000-0000-0000-000000000000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96" creationId="{C5B8BC03-80A6-9749-BE5F-9631DA2FC9EE}"/>
          </ac:spMkLst>
        </pc:spChg>
        <pc:spChg chg="mod">
          <ac:chgData name="Tago Masaki" userId="e657396fbe83e9a5" providerId="LiveId" clId="{0E6B0EA3-0CC6-492D-883F-7266A2758769}" dt="2021-03-01T08:33:46.569" v="9" actId="1036"/>
          <ac:spMkLst>
            <pc:docMk/>
            <pc:sldMk cId="1840328938" sldId="256"/>
            <ac:spMk id="199" creationId="{C5B8BC03-80A6-9749-BE5F-9631DA2FC9EE}"/>
          </ac:spMkLst>
        </pc:sp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6" creationId="{0D451ADA-092C-0140-A340-1B23E6E41969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7" creationId="{6553DD35-D571-DD48-A997-DC81A8334CB1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8" creationId="{8F0C95ED-A0A3-F04E-B7C6-85D52B094FBB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10" creationId="{60AAE05A-AEC3-1340-9EEA-30C80DDC51D6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14" creationId="{0E4F5FF7-0356-F540-BF11-9071362617F6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15" creationId="{372B455D-4009-CC41-955A-753CCCCE7686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18" creationId="{06327A8F-BFA2-D54B-B975-A95A00302346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19" creationId="{B2BE7C0D-47EF-F249-9724-F0623419F0E4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21" creationId="{0400AC7B-F453-DB4D-9ED1-06DB3F844B26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23" creationId="{2BB895A9-6AEB-BC41-8510-7E1715644D7B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25" creationId="{61381394-3D6E-6746-90CE-BE5C62E853B9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29" creationId="{85545527-2943-F842-86E4-B623533211C2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35" creationId="{66C03C1D-050D-0944-9E7F-EDBAF02B43B5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36" creationId="{901312B7-4176-3E4D-B88D-9E52C7EE03F9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40" creationId="{228C425B-A5E7-C741-9092-9C64315ED9E3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41" creationId="{5FDFDB67-8622-6D41-8410-D31F30BF0CED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43" creationId="{5BE31BCA-88DF-9D4A-9F4A-BB994689BB2D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45" creationId="{472C9D82-9EE1-6747-9264-7DF4E3119149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46" creationId="{96E5D51B-C98C-DB43-BE0A-A95074874BD6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48" creationId="{57583491-8A0F-CA42-8281-7CD2B62B0E1D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70" creationId="{FD6DAD56-97DA-42B3-9A85-60BF1E305C2E}"/>
          </ac:cxnSpMkLst>
        </pc:cxnChg>
        <pc:cxnChg chg="mod">
          <ac:chgData name="Tago Masaki" userId="e657396fbe83e9a5" providerId="LiveId" clId="{0E6B0EA3-0CC6-492D-883F-7266A2758769}" dt="2021-03-01T08:33:51.142" v="15" actId="1036"/>
          <ac:cxnSpMkLst>
            <pc:docMk/>
            <pc:sldMk cId="1840328938" sldId="256"/>
            <ac:cxnSpMk id="82" creationId="{F8339F0C-D9E8-457C-9974-BF54A525A5E0}"/>
          </ac:cxnSpMkLst>
        </pc:cxnChg>
        <pc:cxnChg chg="mod">
          <ac:chgData name="Tago Masaki" userId="e657396fbe83e9a5" providerId="LiveId" clId="{0E6B0EA3-0CC6-492D-883F-7266A2758769}" dt="2021-03-01T08:34:23.678" v="51" actId="1036"/>
          <ac:cxnSpMkLst>
            <pc:docMk/>
            <pc:sldMk cId="1840328938" sldId="256"/>
            <ac:cxnSpMk id="108" creationId="{09851608-88C5-438E-82FF-D213BA7E7A2C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110" creationId="{5414ADFF-5662-4528-9905-3D24FF190E17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111" creationId="{2F717590-38A5-4AAC-90F5-309BD82F69FD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163" creationId="{2BB895A9-6AEB-BC41-8510-7E1715644D7B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164" creationId="{61381394-3D6E-6746-90CE-BE5C62E853B9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197" creationId="{2BB895A9-6AEB-BC41-8510-7E1715644D7B}"/>
          </ac:cxnSpMkLst>
        </pc:cxnChg>
        <pc:cxnChg chg="mod">
          <ac:chgData name="Tago Masaki" userId="e657396fbe83e9a5" providerId="LiveId" clId="{0E6B0EA3-0CC6-492D-883F-7266A2758769}" dt="2021-03-01T08:33:46.569" v="9" actId="1036"/>
          <ac:cxnSpMkLst>
            <pc:docMk/>
            <pc:sldMk cId="1840328938" sldId="256"/>
            <ac:cxnSpMk id="198" creationId="{61381394-3D6E-6746-90CE-BE5C62E853B9}"/>
          </ac:cxnSpMkLst>
        </pc:cxnChg>
      </pc:sldChg>
      <pc:sldChg chg="modSp mod">
        <pc:chgData name="Tago Masaki" userId="e657396fbe83e9a5" providerId="LiveId" clId="{0E6B0EA3-0CC6-492D-883F-7266A2758769}" dt="2021-03-01T08:39:10.002" v="66" actId="1076"/>
        <pc:sldMkLst>
          <pc:docMk/>
          <pc:sldMk cId="1997475453" sldId="257"/>
        </pc:sldMkLst>
        <pc:spChg chg="mod">
          <ac:chgData name="Tago Masaki" userId="e657396fbe83e9a5" providerId="LiveId" clId="{0E6B0EA3-0CC6-492D-883F-7266A2758769}" dt="2021-03-01T08:39:10.002" v="66" actId="1076"/>
          <ac:spMkLst>
            <pc:docMk/>
            <pc:sldMk cId="1997475453" sldId="257"/>
            <ac:spMk id="8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2868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770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900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514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6600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30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74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776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29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511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519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8612D-1F7A-40E3-A56F-64EDB5E0F4D2}" type="datetimeFigureOut">
              <a:rPr kumimoji="1" lang="ja-JP" altLang="en-US" smtClean="0"/>
              <a:t>2021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249EFF-2B38-4B98-AF52-BA9D1A734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766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tagomas@cc.saga-u.ac.jp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350539" y="433917"/>
            <a:ext cx="6156922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igh inter-rater reliability of Japanese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edriddenness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anks and cognitive function scores: a hospital-based prospective observational study </a:t>
            </a:r>
          </a:p>
          <a:p>
            <a:pPr>
              <a:lnSpc>
                <a:spcPct val="200000"/>
              </a:lnSpc>
            </a:pP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aoko E. Katsuk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hizuka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Yait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ij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akatan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,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un Yamashit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shimasa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d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u-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ch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Yamashit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200000"/>
              </a:lnSpc>
              <a:buFont typeface="+mj-lt"/>
              <a:buAutoNum type="arabicPeriod"/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Saga University Hospital, Saga, Japan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200000"/>
              </a:lnSpc>
              <a:buFont typeface="+mj-lt"/>
              <a:buAutoNum type="arabicPeriod"/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ivision of Statistical Analysis, Research Support Center, Shizuoka General Hospital, Shizuoka, Japan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200000"/>
              </a:lnSpc>
              <a:buFont typeface="+mj-lt"/>
              <a:buAutoNum type="arabicPeriod"/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ranslational Research Center for Medical Innovation, Foundation for Biomedical Research and Innovation at Kobe, Kobe, Japan 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200000"/>
              </a:lnSpc>
              <a:buFont typeface="+mj-lt"/>
              <a:buAutoNum type="arabicPeriod"/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ua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Kai Foundation and Oda Hospital, Kashima, Japan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asaki Tago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General Medicine, Saga University Hospital, 5-1-1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beshima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Saga 849-8501, Japan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1270" indent="-7620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l: +81 952 34 3238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1270" indent="-7620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ax: +81 952 34 2029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E-mail: </a:t>
            </a:r>
            <a:r>
              <a:rPr lang="en-US" altLang="ja-JP" sz="1200" u="sng" dirty="0">
                <a:solidFill>
                  <a:srgbClr val="0563C1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tagomas@cc.saga-u.ac.jp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997475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FD6DAD56-97DA-42B3-9A85-60BF1E305C2E}"/>
              </a:ext>
            </a:extLst>
          </p:cNvPr>
          <p:cNvCxnSpPr>
            <a:cxnSpLocks/>
            <a:stCxn id="2" idx="2"/>
            <a:endCxn id="28" idx="0"/>
          </p:cNvCxnSpPr>
          <p:nvPr/>
        </p:nvCxnSpPr>
        <p:spPr>
          <a:xfrm>
            <a:off x="1085164" y="1542968"/>
            <a:ext cx="560" cy="271378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5100356-97F8-9146-A0DB-8FAB8BC273D0}"/>
              </a:ext>
            </a:extLst>
          </p:cNvPr>
          <p:cNvSpPr/>
          <p:nvPr/>
        </p:nvSpPr>
        <p:spPr>
          <a:xfrm>
            <a:off x="5714897" y="1203512"/>
            <a:ext cx="595035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Normal</a:t>
            </a: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0D451ADA-092C-0140-A340-1B23E6E41969}"/>
              </a:ext>
            </a:extLst>
          </p:cNvPr>
          <p:cNvCxnSpPr>
            <a:cxnSpLocks/>
            <a:stCxn id="5" idx="2"/>
          </p:cNvCxnSpPr>
          <p:nvPr/>
        </p:nvCxnSpPr>
        <p:spPr>
          <a:xfrm>
            <a:off x="2728568" y="2077686"/>
            <a:ext cx="7554" cy="621915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6553DD35-D571-DD48-A997-DC81A8334CB1}"/>
              </a:ext>
            </a:extLst>
          </p:cNvPr>
          <p:cNvCxnSpPr>
            <a:cxnSpLocks/>
            <a:stCxn id="9" idx="3"/>
            <a:endCxn id="11" idx="1"/>
          </p:cNvCxnSpPr>
          <p:nvPr/>
        </p:nvCxnSpPr>
        <p:spPr>
          <a:xfrm flipV="1">
            <a:off x="4414241" y="1721278"/>
            <a:ext cx="1445727" cy="2294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8F0C95ED-A0A3-F04E-B7C6-85D52B094FBB}"/>
              </a:ext>
            </a:extLst>
          </p:cNvPr>
          <p:cNvCxnSpPr>
            <a:stCxn id="5" idx="3"/>
            <a:endCxn id="9" idx="1"/>
          </p:cNvCxnSpPr>
          <p:nvPr/>
        </p:nvCxnSpPr>
        <p:spPr>
          <a:xfrm>
            <a:off x="3014864" y="1950728"/>
            <a:ext cx="3971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E3DA42F-0EE7-F746-83E2-0D6287165CCE}"/>
              </a:ext>
            </a:extLst>
          </p:cNvPr>
          <p:cNvSpPr/>
          <p:nvPr/>
        </p:nvSpPr>
        <p:spPr>
          <a:xfrm>
            <a:off x="3412044" y="1823770"/>
            <a:ext cx="1002197" cy="2539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By bus or taxi?</a:t>
            </a:r>
            <a:endParaRPr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60AAE05A-AEC3-1340-9EEA-30C80DDC51D6}"/>
              </a:ext>
            </a:extLst>
          </p:cNvPr>
          <p:cNvCxnSpPr>
            <a:cxnSpLocks/>
            <a:stCxn id="9" idx="3"/>
            <a:endCxn id="12" idx="1"/>
          </p:cNvCxnSpPr>
          <p:nvPr/>
        </p:nvCxnSpPr>
        <p:spPr>
          <a:xfrm>
            <a:off x="4414241" y="1950728"/>
            <a:ext cx="1445727" cy="214289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54CBB1EF-F005-0C47-AEED-6353F23865F8}"/>
              </a:ext>
            </a:extLst>
          </p:cNvPr>
          <p:cNvSpPr/>
          <p:nvPr/>
        </p:nvSpPr>
        <p:spPr>
          <a:xfrm>
            <a:off x="5859968" y="1594320"/>
            <a:ext cx="304892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J1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871ADB44-DCA3-AC47-ABB2-82EAF5633910}"/>
              </a:ext>
            </a:extLst>
          </p:cNvPr>
          <p:cNvSpPr/>
          <p:nvPr/>
        </p:nvSpPr>
        <p:spPr>
          <a:xfrm>
            <a:off x="5859968" y="2038059"/>
            <a:ext cx="304892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J2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A0A1AC26-6FBF-8B47-8B57-34E9524CD867}"/>
              </a:ext>
            </a:extLst>
          </p:cNvPr>
          <p:cNvSpPr/>
          <p:nvPr/>
        </p:nvSpPr>
        <p:spPr>
          <a:xfrm>
            <a:off x="2434155" y="2704455"/>
            <a:ext cx="1980086" cy="2539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Is the patient usually on the bed?</a:t>
            </a:r>
            <a:endParaRPr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0E4F5FF7-0356-F540-BF11-9071362617F6}"/>
              </a:ext>
            </a:extLst>
          </p:cNvPr>
          <p:cNvCxnSpPr>
            <a:stCxn id="33" idx="3"/>
            <a:endCxn id="5" idx="1"/>
          </p:cNvCxnSpPr>
          <p:nvPr/>
        </p:nvCxnSpPr>
        <p:spPr>
          <a:xfrm flipV="1">
            <a:off x="1916389" y="1950728"/>
            <a:ext cx="525882" cy="191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372B455D-4009-CC41-955A-753CCCCE7686}"/>
              </a:ext>
            </a:extLst>
          </p:cNvPr>
          <p:cNvCxnSpPr>
            <a:cxnSpLocks/>
            <a:stCxn id="13" idx="3"/>
            <a:endCxn id="16" idx="1"/>
          </p:cNvCxnSpPr>
          <p:nvPr/>
        </p:nvCxnSpPr>
        <p:spPr>
          <a:xfrm>
            <a:off x="4414241" y="2831413"/>
            <a:ext cx="1423285" cy="2210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26FB539-BC1D-5D45-81E1-5AEAEF620037}"/>
              </a:ext>
            </a:extLst>
          </p:cNvPr>
          <p:cNvSpPr/>
          <p:nvPr/>
        </p:nvSpPr>
        <p:spPr>
          <a:xfrm>
            <a:off x="5837526" y="2925537"/>
            <a:ext cx="349776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A2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56EA984-2051-EA4F-B386-36EC4E49EFAE}"/>
              </a:ext>
            </a:extLst>
          </p:cNvPr>
          <p:cNvSpPr/>
          <p:nvPr/>
        </p:nvSpPr>
        <p:spPr>
          <a:xfrm>
            <a:off x="5837526" y="2481798"/>
            <a:ext cx="349776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A1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06327A8F-BFA2-D54B-B975-A95A00302346}"/>
              </a:ext>
            </a:extLst>
          </p:cNvPr>
          <p:cNvCxnSpPr>
            <a:cxnSpLocks/>
            <a:stCxn id="17" idx="1"/>
            <a:endCxn id="13" idx="3"/>
          </p:cNvCxnSpPr>
          <p:nvPr/>
        </p:nvCxnSpPr>
        <p:spPr>
          <a:xfrm flipH="1">
            <a:off x="4414241" y="2608756"/>
            <a:ext cx="1423285" cy="222657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arrow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B2BE7C0D-47EF-F249-9724-F0623419F0E4}"/>
              </a:ext>
            </a:extLst>
          </p:cNvPr>
          <p:cNvCxnSpPr>
            <a:cxnSpLocks/>
            <a:stCxn id="2" idx="3"/>
            <a:endCxn id="4" idx="1"/>
          </p:cNvCxnSpPr>
          <p:nvPr/>
        </p:nvCxnSpPr>
        <p:spPr>
          <a:xfrm flipV="1">
            <a:off x="1921612" y="1330470"/>
            <a:ext cx="3793285" cy="4749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655123A7-91D2-6D4B-A856-66592CBE931C}"/>
              </a:ext>
            </a:extLst>
          </p:cNvPr>
          <p:cNvSpPr/>
          <p:nvPr/>
        </p:nvSpPr>
        <p:spPr>
          <a:xfrm>
            <a:off x="248715" y="3581706"/>
            <a:ext cx="1667674" cy="253916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sit alone?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0400AC7B-F453-DB4D-9ED1-06DB3F844B26}"/>
              </a:ext>
            </a:extLst>
          </p:cNvPr>
          <p:cNvCxnSpPr>
            <a:cxnSpLocks/>
            <a:stCxn id="20" idx="3"/>
            <a:endCxn id="22" idx="1"/>
          </p:cNvCxnSpPr>
          <p:nvPr/>
        </p:nvCxnSpPr>
        <p:spPr>
          <a:xfrm flipV="1">
            <a:off x="1916389" y="3707365"/>
            <a:ext cx="529500" cy="12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A8A6E456-944E-0843-B09E-500F9875D15D}"/>
              </a:ext>
            </a:extLst>
          </p:cNvPr>
          <p:cNvSpPr/>
          <p:nvPr/>
        </p:nvSpPr>
        <p:spPr>
          <a:xfrm>
            <a:off x="2445889" y="3338033"/>
            <a:ext cx="1968352" cy="73866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transfer to the wheelchair by oneself?</a:t>
            </a:r>
          </a:p>
          <a:p>
            <a:pPr algn="just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eat and defecate outside of bed?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2BB895A9-6AEB-BC41-8510-7E1715644D7B}"/>
              </a:ext>
            </a:extLst>
          </p:cNvPr>
          <p:cNvCxnSpPr>
            <a:cxnSpLocks/>
            <a:stCxn id="22" idx="3"/>
            <a:endCxn id="24" idx="1"/>
          </p:cNvCxnSpPr>
          <p:nvPr/>
        </p:nvCxnSpPr>
        <p:spPr>
          <a:xfrm flipV="1">
            <a:off x="4414241" y="3496234"/>
            <a:ext cx="1427293" cy="2111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5900DEB3-9986-B546-BCBC-18213D50EC3E}"/>
              </a:ext>
            </a:extLst>
          </p:cNvPr>
          <p:cNvSpPr/>
          <p:nvPr/>
        </p:nvSpPr>
        <p:spPr>
          <a:xfrm>
            <a:off x="5841534" y="3369276"/>
            <a:ext cx="341760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B1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61381394-3D6E-6746-90CE-BE5C62E853B9}"/>
              </a:ext>
            </a:extLst>
          </p:cNvPr>
          <p:cNvCxnSpPr>
            <a:cxnSpLocks/>
            <a:stCxn id="26" idx="1"/>
            <a:endCxn id="22" idx="3"/>
          </p:cNvCxnSpPr>
          <p:nvPr/>
        </p:nvCxnSpPr>
        <p:spPr>
          <a:xfrm flipH="1" flipV="1">
            <a:off x="4414241" y="3707365"/>
            <a:ext cx="1427293" cy="232608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arrow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9D7979A3-BB74-DF49-B0F8-75816FAF52F3}"/>
              </a:ext>
            </a:extLst>
          </p:cNvPr>
          <p:cNvSpPr/>
          <p:nvPr/>
        </p:nvSpPr>
        <p:spPr>
          <a:xfrm>
            <a:off x="5841534" y="3813015"/>
            <a:ext cx="341760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B2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85249E6-1CB3-C447-B7C9-FE4ADB055383}"/>
              </a:ext>
            </a:extLst>
          </p:cNvPr>
          <p:cNvSpPr txBox="1"/>
          <p:nvPr/>
        </p:nvSpPr>
        <p:spPr>
          <a:xfrm>
            <a:off x="251887" y="4256751"/>
            <a:ext cx="1667674" cy="253916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r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l over</a:t>
            </a:r>
            <a:r>
              <a:rPr kumimoji="1"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?</a:t>
            </a:r>
            <a:endParaRPr kumimoji="1"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85545527-2943-F842-86E4-B623533211C2}"/>
              </a:ext>
            </a:extLst>
          </p:cNvPr>
          <p:cNvCxnSpPr>
            <a:cxnSpLocks/>
            <a:stCxn id="28" idx="3"/>
            <a:endCxn id="30" idx="1"/>
          </p:cNvCxnSpPr>
          <p:nvPr/>
        </p:nvCxnSpPr>
        <p:spPr>
          <a:xfrm>
            <a:off x="1919561" y="4383709"/>
            <a:ext cx="391796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DC595FD1-2105-3E4D-88B6-3E8CF2B7941C}"/>
              </a:ext>
            </a:extLst>
          </p:cNvPr>
          <p:cNvSpPr/>
          <p:nvPr/>
        </p:nvSpPr>
        <p:spPr>
          <a:xfrm>
            <a:off x="5837526" y="4256751"/>
            <a:ext cx="349776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1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C2EF0F19-B65D-0A4A-8CD6-B3C899082C43}"/>
              </a:ext>
            </a:extLst>
          </p:cNvPr>
          <p:cNvSpPr/>
          <p:nvPr/>
        </p:nvSpPr>
        <p:spPr>
          <a:xfrm>
            <a:off x="5837527" y="4825989"/>
            <a:ext cx="373521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2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6D00FF1E-3502-2F45-A70C-1EF552092507}"/>
              </a:ext>
            </a:extLst>
          </p:cNvPr>
          <p:cNvSpPr/>
          <p:nvPr/>
        </p:nvSpPr>
        <p:spPr>
          <a:xfrm>
            <a:off x="248715" y="1825688"/>
            <a:ext cx="1667674" cy="253916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go out?</a:t>
            </a:r>
            <a:endParaRPr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A0364C2-5E42-594E-8796-2B869401FED1}"/>
              </a:ext>
            </a:extLst>
          </p:cNvPr>
          <p:cNvSpPr txBox="1"/>
          <p:nvPr/>
        </p:nvSpPr>
        <p:spPr>
          <a:xfrm>
            <a:off x="468456" y="570612"/>
            <a:ext cx="2402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The MHLW </a:t>
            </a:r>
            <a:r>
              <a:rPr kumimoji="1" lang="en-US" altLang="ja-JP" sz="1200" b="1" dirty="0" err="1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Bedriddenness</a:t>
            </a:r>
            <a:r>
              <a:rPr kumimoji="1" lang="en-US" altLang="ja-JP" sz="1200" b="1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ranks</a:t>
            </a:r>
            <a:endParaRPr kumimoji="1" lang="ja-JP" altLang="en-US" sz="1200" b="1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66C03C1D-050D-0944-9E7F-EDBAF02B43B5}"/>
              </a:ext>
            </a:extLst>
          </p:cNvPr>
          <p:cNvCxnSpPr/>
          <p:nvPr/>
        </p:nvCxnSpPr>
        <p:spPr>
          <a:xfrm>
            <a:off x="4416758" y="972214"/>
            <a:ext cx="5872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901312B7-4176-3E4D-B88D-9E52C7EE03F9}"/>
              </a:ext>
            </a:extLst>
          </p:cNvPr>
          <p:cNvCxnSpPr>
            <a:cxnSpLocks/>
          </p:cNvCxnSpPr>
          <p:nvPr/>
        </p:nvCxnSpPr>
        <p:spPr>
          <a:xfrm flipH="1">
            <a:off x="5274799" y="972214"/>
            <a:ext cx="839970" cy="0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arrow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5FC4413-1013-9D4E-9A38-62BE0F8F46CE}"/>
              </a:ext>
            </a:extLst>
          </p:cNvPr>
          <p:cNvSpPr txBox="1"/>
          <p:nvPr/>
        </p:nvSpPr>
        <p:spPr>
          <a:xfrm>
            <a:off x="4486894" y="745164"/>
            <a:ext cx="3946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Yes</a:t>
            </a:r>
            <a:endParaRPr kumimoji="1"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2C60E49-1252-E945-9E20-DDA117FDA1E3}"/>
              </a:ext>
            </a:extLst>
          </p:cNvPr>
          <p:cNvSpPr txBox="1"/>
          <p:nvPr/>
        </p:nvSpPr>
        <p:spPr>
          <a:xfrm>
            <a:off x="5492702" y="745164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No</a:t>
            </a:r>
            <a:endParaRPr kumimoji="1"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228C425B-A5E7-C741-9092-9C64315ED9E3}"/>
              </a:ext>
            </a:extLst>
          </p:cNvPr>
          <p:cNvCxnSpPr>
            <a:cxnSpLocks/>
            <a:stCxn id="49" idx="3"/>
            <a:endCxn id="92" idx="1"/>
          </p:cNvCxnSpPr>
          <p:nvPr/>
        </p:nvCxnSpPr>
        <p:spPr>
          <a:xfrm flipV="1">
            <a:off x="3345172" y="9057120"/>
            <a:ext cx="2177871" cy="27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5FDFDB67-8622-6D41-8410-D31F30BF0CED}"/>
              </a:ext>
            </a:extLst>
          </p:cNvPr>
          <p:cNvCxnSpPr>
            <a:cxnSpLocks/>
            <a:stCxn id="47" idx="3"/>
            <a:endCxn id="179" idx="1"/>
          </p:cNvCxnSpPr>
          <p:nvPr/>
        </p:nvCxnSpPr>
        <p:spPr>
          <a:xfrm>
            <a:off x="3360607" y="8326003"/>
            <a:ext cx="385318" cy="44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60E95549-2D1E-B040-893B-2C84A8D499E1}"/>
              </a:ext>
            </a:extLst>
          </p:cNvPr>
          <p:cNvSpPr/>
          <p:nvPr/>
        </p:nvSpPr>
        <p:spPr>
          <a:xfrm>
            <a:off x="189269" y="5998243"/>
            <a:ext cx="3201811" cy="253916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oes the patient have delirium or self-inflicted harm?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5BE31BCA-88DF-9D4A-9F4A-BB994689BB2D}"/>
              </a:ext>
            </a:extLst>
          </p:cNvPr>
          <p:cNvCxnSpPr>
            <a:cxnSpLocks/>
            <a:stCxn id="42" idx="3"/>
            <a:endCxn id="44" idx="1"/>
          </p:cNvCxnSpPr>
          <p:nvPr/>
        </p:nvCxnSpPr>
        <p:spPr>
          <a:xfrm>
            <a:off x="3391080" y="6125201"/>
            <a:ext cx="2124604" cy="23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C914C37A-8E70-E24F-B2C0-A74D9BD59B87}"/>
              </a:ext>
            </a:extLst>
          </p:cNvPr>
          <p:cNvSpPr/>
          <p:nvPr/>
        </p:nvSpPr>
        <p:spPr>
          <a:xfrm>
            <a:off x="5515684" y="6000574"/>
            <a:ext cx="515962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M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472C9D82-9EE1-6747-9264-7DF4E3119149}"/>
              </a:ext>
            </a:extLst>
          </p:cNvPr>
          <p:cNvCxnSpPr>
            <a:cxnSpLocks/>
            <a:stCxn id="57" idx="3"/>
            <a:endCxn id="90" idx="1"/>
          </p:cNvCxnSpPr>
          <p:nvPr/>
        </p:nvCxnSpPr>
        <p:spPr>
          <a:xfrm flipV="1">
            <a:off x="3391080" y="6802498"/>
            <a:ext cx="2124604" cy="7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96E5D51B-C98C-DB43-BE0A-A95074874BD6}"/>
              </a:ext>
            </a:extLst>
          </p:cNvPr>
          <p:cNvCxnSpPr>
            <a:cxnSpLocks/>
            <a:stCxn id="42" idx="2"/>
            <a:endCxn id="63" idx="0"/>
          </p:cNvCxnSpPr>
          <p:nvPr/>
        </p:nvCxnSpPr>
        <p:spPr>
          <a:xfrm flipH="1">
            <a:off x="1790174" y="6252159"/>
            <a:ext cx="1" cy="3338555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4316E617-51CB-2545-993D-E87BD0D81A0D}"/>
              </a:ext>
            </a:extLst>
          </p:cNvPr>
          <p:cNvSpPr/>
          <p:nvPr/>
        </p:nvSpPr>
        <p:spPr>
          <a:xfrm>
            <a:off x="189269" y="8037462"/>
            <a:ext cx="3171338" cy="57708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make decisions about things under supervision of someone else? Does the patient have any difficulty in communicating?</a:t>
            </a:r>
          </a:p>
        </p:txBody>
      </p: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57583491-8A0F-CA42-8281-7CD2B62B0E1D}"/>
              </a:ext>
            </a:extLst>
          </p:cNvPr>
          <p:cNvCxnSpPr>
            <a:cxnSpLocks/>
            <a:stCxn id="59" idx="3"/>
            <a:endCxn id="159" idx="1"/>
          </p:cNvCxnSpPr>
          <p:nvPr/>
        </p:nvCxnSpPr>
        <p:spPr>
          <a:xfrm flipV="1">
            <a:off x="3375415" y="7536041"/>
            <a:ext cx="378906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41FF6500-BF8D-174E-929E-5847DCB65016}"/>
              </a:ext>
            </a:extLst>
          </p:cNvPr>
          <p:cNvSpPr/>
          <p:nvPr/>
        </p:nvSpPr>
        <p:spPr>
          <a:xfrm>
            <a:off x="204703" y="8771301"/>
            <a:ext cx="3140469" cy="57708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an the patient have some dementia symptoms but still have good communication and make decisions about things by oneself ?</a:t>
            </a: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C5B8BC03-80A6-9749-BE5F-9631DA2FC9EE}"/>
              </a:ext>
            </a:extLst>
          </p:cNvPr>
          <p:cNvSpPr/>
          <p:nvPr/>
        </p:nvSpPr>
        <p:spPr>
          <a:xfrm>
            <a:off x="5515684" y="7199586"/>
            <a:ext cx="508603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3a</a:t>
            </a: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29A9552C-B393-C847-9540-29FFABF88F0B}"/>
              </a:ext>
            </a:extLst>
          </p:cNvPr>
          <p:cNvSpPr/>
          <p:nvPr/>
        </p:nvSpPr>
        <p:spPr>
          <a:xfrm>
            <a:off x="189269" y="6514690"/>
            <a:ext cx="3201811" cy="57708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oes the patient require constant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istance </a:t>
            </a:r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ue to dementia? e.g. in eating, toileting, changing, and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ubled</a:t>
            </a:r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behaviors except for M</a:t>
            </a:r>
            <a:endParaRPr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DC23E7A5-62A5-F840-9693-8F0615E83ED4}"/>
              </a:ext>
            </a:extLst>
          </p:cNvPr>
          <p:cNvSpPr/>
          <p:nvPr/>
        </p:nvSpPr>
        <p:spPr>
          <a:xfrm>
            <a:off x="189269" y="7247501"/>
            <a:ext cx="3186146" cy="577081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oes the patient need some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istance</a:t>
            </a:r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due to dementia? dementia? e.g. in eating, toileting, changing, and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ubled</a:t>
            </a:r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behaviors except for M</a:t>
            </a:r>
            <a:endParaRPr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13BDD7D-23A5-B743-973B-93279F2B16A5}"/>
              </a:ext>
            </a:extLst>
          </p:cNvPr>
          <p:cNvSpPr txBox="1"/>
          <p:nvPr/>
        </p:nvSpPr>
        <p:spPr>
          <a:xfrm>
            <a:off x="1492656" y="9590714"/>
            <a:ext cx="595035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0ABC092-09F1-1F40-9A0D-91FDAA4CAF20}"/>
              </a:ext>
            </a:extLst>
          </p:cNvPr>
          <p:cNvSpPr/>
          <p:nvPr/>
        </p:nvSpPr>
        <p:spPr>
          <a:xfrm>
            <a:off x="248715" y="1127470"/>
            <a:ext cx="1672897" cy="415498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oes the patient have any problem?</a:t>
            </a:r>
            <a:endParaRPr lang="ja-JP" altLang="ja-JP" sz="1050" kern="1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5D82A814-52DD-FA4B-B0B6-D82B2618D4E2}"/>
              </a:ext>
            </a:extLst>
          </p:cNvPr>
          <p:cNvSpPr/>
          <p:nvPr/>
        </p:nvSpPr>
        <p:spPr>
          <a:xfrm>
            <a:off x="2442271" y="1823770"/>
            <a:ext cx="572593" cy="253916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Alone?</a:t>
            </a:r>
            <a:endParaRPr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F8339F0C-D9E8-457C-9974-BF54A525A5E0}"/>
              </a:ext>
            </a:extLst>
          </p:cNvPr>
          <p:cNvCxnSpPr>
            <a:cxnSpLocks/>
          </p:cNvCxnSpPr>
          <p:nvPr/>
        </p:nvCxnSpPr>
        <p:spPr>
          <a:xfrm flipV="1">
            <a:off x="163835" y="5141439"/>
            <a:ext cx="6516035" cy="525"/>
          </a:xfrm>
          <a:prstGeom prst="line">
            <a:avLst/>
          </a:prstGeom>
          <a:ln w="34925">
            <a:prstDash val="sysDash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F949138-3D7F-477E-A27B-E12819C4B58B}"/>
              </a:ext>
            </a:extLst>
          </p:cNvPr>
          <p:cNvSpPr txBox="1"/>
          <p:nvPr/>
        </p:nvSpPr>
        <p:spPr>
          <a:xfrm>
            <a:off x="463984" y="5253891"/>
            <a:ext cx="34306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The MHLW 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ognitive function scores</a:t>
            </a:r>
            <a:endParaRPr lang="ja-JP" altLang="en-US" sz="1200" b="1" dirty="0"/>
          </a:p>
        </p:txBody>
      </p:sp>
      <p:cxnSp>
        <p:nvCxnSpPr>
          <p:cNvPr id="108" name="直線矢印コネクタ 107">
            <a:extLst>
              <a:ext uri="{FF2B5EF4-FFF2-40B4-BE49-F238E27FC236}">
                <a16:creationId xmlns:a16="http://schemas.microsoft.com/office/drawing/2014/main" id="{09851608-88C5-438E-82FF-D213BA7E7A2C}"/>
              </a:ext>
            </a:extLst>
          </p:cNvPr>
          <p:cNvCxnSpPr>
            <a:cxnSpLocks/>
            <a:endCxn id="32" idx="1"/>
          </p:cNvCxnSpPr>
          <p:nvPr/>
        </p:nvCxnSpPr>
        <p:spPr>
          <a:xfrm>
            <a:off x="1919313" y="4404257"/>
            <a:ext cx="3918214" cy="548690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10" name="直線矢印コネクタ 109">
            <a:extLst>
              <a:ext uri="{FF2B5EF4-FFF2-40B4-BE49-F238E27FC236}">
                <a16:creationId xmlns:a16="http://schemas.microsoft.com/office/drawing/2014/main" id="{5414ADFF-5662-4528-9905-3D24FF190E17}"/>
              </a:ext>
            </a:extLst>
          </p:cNvPr>
          <p:cNvCxnSpPr/>
          <p:nvPr/>
        </p:nvCxnSpPr>
        <p:spPr>
          <a:xfrm>
            <a:off x="4418124" y="5681327"/>
            <a:ext cx="5872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1" name="直線矢印コネクタ 110">
            <a:extLst>
              <a:ext uri="{FF2B5EF4-FFF2-40B4-BE49-F238E27FC236}">
                <a16:creationId xmlns:a16="http://schemas.microsoft.com/office/drawing/2014/main" id="{2F717590-38A5-4AAC-90F5-309BD82F69FD}"/>
              </a:ext>
            </a:extLst>
          </p:cNvPr>
          <p:cNvCxnSpPr>
            <a:cxnSpLocks/>
          </p:cNvCxnSpPr>
          <p:nvPr/>
        </p:nvCxnSpPr>
        <p:spPr>
          <a:xfrm flipH="1">
            <a:off x="5276165" y="5681327"/>
            <a:ext cx="839970" cy="0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arrow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2FAEEAC3-81C5-4053-8518-8DDEAE1CA383}"/>
              </a:ext>
            </a:extLst>
          </p:cNvPr>
          <p:cNvSpPr txBox="1"/>
          <p:nvPr/>
        </p:nvSpPr>
        <p:spPr>
          <a:xfrm>
            <a:off x="4488260" y="5454277"/>
            <a:ext cx="3946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Yes</a:t>
            </a:r>
            <a:endParaRPr kumimoji="1"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CBC03C5-0C22-46AA-8AC2-81007944D098}"/>
              </a:ext>
            </a:extLst>
          </p:cNvPr>
          <p:cNvSpPr txBox="1"/>
          <p:nvPr/>
        </p:nvSpPr>
        <p:spPr>
          <a:xfrm>
            <a:off x="5494068" y="5454277"/>
            <a:ext cx="3497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No</a:t>
            </a:r>
            <a:endParaRPr kumimoji="1" lang="ja-JP" altLang="en-US" sz="105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C5B8BC03-80A6-9749-BE5F-9631DA2FC9EE}"/>
              </a:ext>
            </a:extLst>
          </p:cNvPr>
          <p:cNvSpPr/>
          <p:nvPr/>
        </p:nvSpPr>
        <p:spPr>
          <a:xfrm>
            <a:off x="5515684" y="6675540"/>
            <a:ext cx="508604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C5B8BC03-80A6-9749-BE5F-9631DA2FC9EE}"/>
              </a:ext>
            </a:extLst>
          </p:cNvPr>
          <p:cNvSpPr/>
          <p:nvPr/>
        </p:nvSpPr>
        <p:spPr>
          <a:xfrm>
            <a:off x="5523043" y="8930162"/>
            <a:ext cx="508603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59" name="正方形/長方形 158"/>
          <p:cNvSpPr/>
          <p:nvPr/>
        </p:nvSpPr>
        <p:spPr>
          <a:xfrm>
            <a:off x="3754321" y="7409083"/>
            <a:ext cx="1476273" cy="25391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inly Daytime?</a:t>
            </a:r>
          </a:p>
        </p:txBody>
      </p:sp>
      <p:cxnSp>
        <p:nvCxnSpPr>
          <p:cNvPr id="163" name="直線矢印コネクタ 162">
            <a:extLst>
              <a:ext uri="{FF2B5EF4-FFF2-40B4-BE49-F238E27FC236}">
                <a16:creationId xmlns:a16="http://schemas.microsoft.com/office/drawing/2014/main" id="{2BB895A9-6AEB-BC41-8510-7E1715644D7B}"/>
              </a:ext>
            </a:extLst>
          </p:cNvPr>
          <p:cNvCxnSpPr>
            <a:cxnSpLocks/>
            <a:stCxn id="159" idx="3"/>
            <a:endCxn id="55" idx="1"/>
          </p:cNvCxnSpPr>
          <p:nvPr/>
        </p:nvCxnSpPr>
        <p:spPr>
          <a:xfrm flipV="1">
            <a:off x="5230594" y="7326544"/>
            <a:ext cx="285090" cy="2094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4" name="直線矢印コネクタ 163">
            <a:extLst>
              <a:ext uri="{FF2B5EF4-FFF2-40B4-BE49-F238E27FC236}">
                <a16:creationId xmlns:a16="http://schemas.microsoft.com/office/drawing/2014/main" id="{61381394-3D6E-6746-90CE-BE5C62E853B9}"/>
              </a:ext>
            </a:extLst>
          </p:cNvPr>
          <p:cNvCxnSpPr>
            <a:cxnSpLocks/>
            <a:stCxn id="173" idx="1"/>
            <a:endCxn id="159" idx="3"/>
          </p:cNvCxnSpPr>
          <p:nvPr/>
        </p:nvCxnSpPr>
        <p:spPr>
          <a:xfrm flipH="1" flipV="1">
            <a:off x="5230594" y="7536041"/>
            <a:ext cx="290968" cy="185234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arrow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C5B8BC03-80A6-9749-BE5F-9631DA2FC9EE}"/>
              </a:ext>
            </a:extLst>
          </p:cNvPr>
          <p:cNvSpPr/>
          <p:nvPr/>
        </p:nvSpPr>
        <p:spPr>
          <a:xfrm>
            <a:off x="5521562" y="7594317"/>
            <a:ext cx="508603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3b</a:t>
            </a:r>
          </a:p>
        </p:txBody>
      </p:sp>
      <p:sp>
        <p:nvSpPr>
          <p:cNvPr id="179" name="正方形/長方形 178"/>
          <p:cNvSpPr/>
          <p:nvPr/>
        </p:nvSpPr>
        <p:spPr>
          <a:xfrm>
            <a:off x="3745925" y="8203461"/>
            <a:ext cx="1484670" cy="25391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y outside the home?</a:t>
            </a:r>
          </a:p>
        </p:txBody>
      </p:sp>
      <p:sp>
        <p:nvSpPr>
          <p:cNvPr id="196" name="正方形/長方形 195">
            <a:extLst>
              <a:ext uri="{FF2B5EF4-FFF2-40B4-BE49-F238E27FC236}">
                <a16:creationId xmlns:a16="http://schemas.microsoft.com/office/drawing/2014/main" id="{C5B8BC03-80A6-9749-BE5F-9631DA2FC9EE}"/>
              </a:ext>
            </a:extLst>
          </p:cNvPr>
          <p:cNvSpPr/>
          <p:nvPr/>
        </p:nvSpPr>
        <p:spPr>
          <a:xfrm>
            <a:off x="5523043" y="8009275"/>
            <a:ext cx="508603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2a</a:t>
            </a:r>
          </a:p>
        </p:txBody>
      </p:sp>
      <p:cxnSp>
        <p:nvCxnSpPr>
          <p:cNvPr id="197" name="直線矢印コネクタ 196">
            <a:extLst>
              <a:ext uri="{FF2B5EF4-FFF2-40B4-BE49-F238E27FC236}">
                <a16:creationId xmlns:a16="http://schemas.microsoft.com/office/drawing/2014/main" id="{2BB895A9-6AEB-BC41-8510-7E1715644D7B}"/>
              </a:ext>
            </a:extLst>
          </p:cNvPr>
          <p:cNvCxnSpPr>
            <a:cxnSpLocks/>
            <a:stCxn id="179" idx="3"/>
            <a:endCxn id="196" idx="1"/>
          </p:cNvCxnSpPr>
          <p:nvPr/>
        </p:nvCxnSpPr>
        <p:spPr>
          <a:xfrm flipV="1">
            <a:off x="5230595" y="8136233"/>
            <a:ext cx="292448" cy="1941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8" name="直線矢印コネクタ 197">
            <a:extLst>
              <a:ext uri="{FF2B5EF4-FFF2-40B4-BE49-F238E27FC236}">
                <a16:creationId xmlns:a16="http://schemas.microsoft.com/office/drawing/2014/main" id="{61381394-3D6E-6746-90CE-BE5C62E853B9}"/>
              </a:ext>
            </a:extLst>
          </p:cNvPr>
          <p:cNvCxnSpPr>
            <a:cxnSpLocks/>
            <a:stCxn id="199" idx="1"/>
            <a:endCxn id="179" idx="3"/>
          </p:cNvCxnSpPr>
          <p:nvPr/>
        </p:nvCxnSpPr>
        <p:spPr>
          <a:xfrm flipH="1" flipV="1">
            <a:off x="5230595" y="8330419"/>
            <a:ext cx="298326" cy="200545"/>
          </a:xfrm>
          <a:prstGeom prst="straightConnector1">
            <a:avLst/>
          </a:prstGeom>
          <a:ln w="9525" cap="flat" cmpd="sng" algn="ctr">
            <a:solidFill>
              <a:schemeClr val="tx1"/>
            </a:solidFill>
            <a:prstDash val="dash"/>
            <a:round/>
            <a:headEnd type="arrow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99" name="正方形/長方形 198">
            <a:extLst>
              <a:ext uri="{FF2B5EF4-FFF2-40B4-BE49-F238E27FC236}">
                <a16:creationId xmlns:a16="http://schemas.microsoft.com/office/drawing/2014/main" id="{C5B8BC03-80A6-9749-BE5F-9631DA2FC9EE}"/>
              </a:ext>
            </a:extLst>
          </p:cNvPr>
          <p:cNvSpPr/>
          <p:nvPr/>
        </p:nvSpPr>
        <p:spPr>
          <a:xfrm>
            <a:off x="5528921" y="8404006"/>
            <a:ext cx="508603" cy="25391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sz="1050" kern="1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2b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04703" y="567751"/>
            <a:ext cx="253461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204703" y="5254378"/>
            <a:ext cx="253461" cy="27699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9873C2E-08D1-C842-BBFF-28D6F6CA94B4}"/>
              </a:ext>
            </a:extLst>
          </p:cNvPr>
          <p:cNvSpPr txBox="1"/>
          <p:nvPr/>
        </p:nvSpPr>
        <p:spPr>
          <a:xfrm>
            <a:off x="1082552" y="1549998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1</a:t>
            </a:r>
            <a:endParaRPr kumimoji="1" lang="ja-JP" altLang="en-US" sz="1100" i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96284BE-8E35-D74A-B20F-ED007620647E}"/>
              </a:ext>
            </a:extLst>
          </p:cNvPr>
          <p:cNvSpPr txBox="1"/>
          <p:nvPr/>
        </p:nvSpPr>
        <p:spPr>
          <a:xfrm>
            <a:off x="1082552" y="266392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2</a:t>
            </a:r>
            <a:endParaRPr kumimoji="1" lang="ja-JP" altLang="en-US" sz="1100" i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1860C8A-4ADC-E145-AF41-DBB30A94A1EC}"/>
              </a:ext>
            </a:extLst>
          </p:cNvPr>
          <p:cNvSpPr txBox="1"/>
          <p:nvPr/>
        </p:nvSpPr>
        <p:spPr>
          <a:xfrm>
            <a:off x="1090980" y="3902602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3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F3A0620-5D9D-EF47-9AFD-E2C986CCE7B7}"/>
              </a:ext>
            </a:extLst>
          </p:cNvPr>
          <p:cNvSpPr txBox="1"/>
          <p:nvPr/>
        </p:nvSpPr>
        <p:spPr>
          <a:xfrm>
            <a:off x="5128660" y="4496905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4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A4A628D2-8993-DE4B-BB26-81668664C50A}"/>
              </a:ext>
            </a:extLst>
          </p:cNvPr>
          <p:cNvSpPr txBox="1"/>
          <p:nvPr/>
        </p:nvSpPr>
        <p:spPr>
          <a:xfrm>
            <a:off x="1922839" y="1686691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2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5ECDFF2-3ED3-6544-BF62-5AFD12DC8F4E}"/>
              </a:ext>
            </a:extLst>
          </p:cNvPr>
          <p:cNvSpPr txBox="1"/>
          <p:nvPr/>
        </p:nvSpPr>
        <p:spPr>
          <a:xfrm>
            <a:off x="2728567" y="2277797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3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D1984872-FF01-4B48-AB22-6C14494317EA}"/>
              </a:ext>
            </a:extLst>
          </p:cNvPr>
          <p:cNvSpPr txBox="1"/>
          <p:nvPr/>
        </p:nvSpPr>
        <p:spPr>
          <a:xfrm>
            <a:off x="5167769" y="2704125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4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C5363C3-9801-0C4D-8517-EB14D8F6BF04}"/>
              </a:ext>
            </a:extLst>
          </p:cNvPr>
          <p:cNvSpPr txBox="1"/>
          <p:nvPr/>
        </p:nvSpPr>
        <p:spPr>
          <a:xfrm>
            <a:off x="1818226" y="7034824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2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C4D573E1-5A25-2F42-8E3B-21C2D5566759}"/>
              </a:ext>
            </a:extLst>
          </p:cNvPr>
          <p:cNvSpPr txBox="1"/>
          <p:nvPr/>
        </p:nvSpPr>
        <p:spPr>
          <a:xfrm>
            <a:off x="1790173" y="7801396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3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89B78755-6CFA-904A-B5B4-71F0D7B1E368}"/>
              </a:ext>
            </a:extLst>
          </p:cNvPr>
          <p:cNvSpPr txBox="1"/>
          <p:nvPr/>
        </p:nvSpPr>
        <p:spPr>
          <a:xfrm>
            <a:off x="1790173" y="8559319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4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E06997E3-F31B-D741-BB90-486974DD42F9}"/>
              </a:ext>
            </a:extLst>
          </p:cNvPr>
          <p:cNvSpPr txBox="1"/>
          <p:nvPr/>
        </p:nvSpPr>
        <p:spPr>
          <a:xfrm>
            <a:off x="1782342" y="9319465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5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A33A3D1-800F-B44F-AE4A-6690DB50D647}"/>
              </a:ext>
            </a:extLst>
          </p:cNvPr>
          <p:cNvSpPr txBox="1"/>
          <p:nvPr/>
        </p:nvSpPr>
        <p:spPr>
          <a:xfrm>
            <a:off x="3352065" y="7191892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3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CED8A518-C47D-3C42-A612-F0D9BCC53012}"/>
              </a:ext>
            </a:extLst>
          </p:cNvPr>
          <p:cNvSpPr txBox="1"/>
          <p:nvPr/>
        </p:nvSpPr>
        <p:spPr>
          <a:xfrm>
            <a:off x="4953772" y="7165629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4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E349939-B4CB-1C45-B9EE-77C54C425760}"/>
              </a:ext>
            </a:extLst>
          </p:cNvPr>
          <p:cNvSpPr txBox="1"/>
          <p:nvPr/>
        </p:nvSpPr>
        <p:spPr>
          <a:xfrm>
            <a:off x="1790173" y="6248312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1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B720766-0609-5040-8E73-2D913A4E86EE}"/>
              </a:ext>
            </a:extLst>
          </p:cNvPr>
          <p:cNvSpPr txBox="1"/>
          <p:nvPr/>
        </p:nvSpPr>
        <p:spPr>
          <a:xfrm>
            <a:off x="3360606" y="7971716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4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61231EB2-A82C-214F-B6D9-5C1BFCEFAE6A}"/>
              </a:ext>
            </a:extLst>
          </p:cNvPr>
          <p:cNvSpPr txBox="1"/>
          <p:nvPr/>
        </p:nvSpPr>
        <p:spPr>
          <a:xfrm>
            <a:off x="4961512" y="7948818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p 5</a:t>
            </a:r>
            <a:endParaRPr kumimoji="1" lang="ja-JP" altLang="en-US" sz="1100" i="1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CC21B440-7E36-47B4-93E9-4A80B7A45FF1}"/>
              </a:ext>
            </a:extLst>
          </p:cNvPr>
          <p:cNvSpPr txBox="1"/>
          <p:nvPr/>
        </p:nvSpPr>
        <p:spPr>
          <a:xfrm>
            <a:off x="174396" y="84438"/>
            <a:ext cx="655785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S1, Figure. The flowchart used by the assessor for MHLW </a:t>
            </a:r>
            <a:r>
              <a:rPr lang="en-US" altLang="ja-JP" sz="1200" b="1" i="0" dirty="0" err="1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bedriddenness</a:t>
            </a:r>
            <a:r>
              <a:rPr lang="en-US" altLang="ja-JP" sz="1200" b="1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 ranks (A) and cognitive function scores (B).</a:t>
            </a:r>
            <a:endParaRPr lang="ja-JP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840328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412</Words>
  <Application>Microsoft Office PowerPoint</Application>
  <PresentationFormat>A4 210 x 297 mm</PresentationFormat>
  <Paragraphs>7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香月　尚子</dc:creator>
  <cp:lastModifiedBy>Tago Masaki</cp:lastModifiedBy>
  <cp:revision>18</cp:revision>
  <dcterms:created xsi:type="dcterms:W3CDTF">2020-07-09T01:21:35Z</dcterms:created>
  <dcterms:modified xsi:type="dcterms:W3CDTF">2021-03-01T08:39:11Z</dcterms:modified>
</cp:coreProperties>
</file>